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3" d="100"/>
          <a:sy n="103" d="100"/>
        </p:scale>
        <p:origin x="-204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PH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P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E9A9CD-DE84-4EEE-ABAB-E9C50D14D227}" type="datetimeFigureOut">
              <a:rPr lang="en-PH" smtClean="0"/>
              <a:t>24/01/2020</a:t>
            </a:fld>
            <a:endParaRPr lang="en-P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F87CA5-29BC-48A9-86AE-C053E02178A2}" type="slidenum">
              <a:rPr lang="en-PH" smtClean="0"/>
              <a:t>‹#›</a:t>
            </a:fld>
            <a:endParaRPr lang="en-PH"/>
          </a:p>
        </p:txBody>
      </p:sp>
    </p:spTree>
    <p:extLst>
      <p:ext uri="{BB962C8B-B14F-4D97-AF65-F5344CB8AC3E}">
        <p14:creationId xmlns:p14="http://schemas.microsoft.com/office/powerpoint/2010/main" val="10416004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PH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P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E9A9CD-DE84-4EEE-ABAB-E9C50D14D227}" type="datetimeFigureOut">
              <a:rPr lang="en-PH" smtClean="0"/>
              <a:t>24/01/2020</a:t>
            </a:fld>
            <a:endParaRPr lang="en-P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F87CA5-29BC-48A9-86AE-C053E02178A2}" type="slidenum">
              <a:rPr lang="en-PH" smtClean="0"/>
              <a:t>‹#›</a:t>
            </a:fld>
            <a:endParaRPr lang="en-PH"/>
          </a:p>
        </p:txBody>
      </p:sp>
    </p:spTree>
    <p:extLst>
      <p:ext uri="{BB962C8B-B14F-4D97-AF65-F5344CB8AC3E}">
        <p14:creationId xmlns:p14="http://schemas.microsoft.com/office/powerpoint/2010/main" val="8799128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PH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P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E9A9CD-DE84-4EEE-ABAB-E9C50D14D227}" type="datetimeFigureOut">
              <a:rPr lang="en-PH" smtClean="0"/>
              <a:t>24/01/2020</a:t>
            </a:fld>
            <a:endParaRPr lang="en-P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F87CA5-29BC-48A9-86AE-C053E02178A2}" type="slidenum">
              <a:rPr lang="en-PH" smtClean="0"/>
              <a:t>‹#›</a:t>
            </a:fld>
            <a:endParaRPr lang="en-PH"/>
          </a:p>
        </p:txBody>
      </p:sp>
    </p:spTree>
    <p:extLst>
      <p:ext uri="{BB962C8B-B14F-4D97-AF65-F5344CB8AC3E}">
        <p14:creationId xmlns:p14="http://schemas.microsoft.com/office/powerpoint/2010/main" val="18098757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PH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P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E9A9CD-DE84-4EEE-ABAB-E9C50D14D227}" type="datetimeFigureOut">
              <a:rPr lang="en-PH" smtClean="0"/>
              <a:t>24/01/2020</a:t>
            </a:fld>
            <a:endParaRPr lang="en-P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F87CA5-29BC-48A9-86AE-C053E02178A2}" type="slidenum">
              <a:rPr lang="en-PH" smtClean="0"/>
              <a:t>‹#›</a:t>
            </a:fld>
            <a:endParaRPr lang="en-PH"/>
          </a:p>
        </p:txBody>
      </p:sp>
    </p:spTree>
    <p:extLst>
      <p:ext uri="{BB962C8B-B14F-4D97-AF65-F5344CB8AC3E}">
        <p14:creationId xmlns:p14="http://schemas.microsoft.com/office/powerpoint/2010/main" val="36486568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PH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E9A9CD-DE84-4EEE-ABAB-E9C50D14D227}" type="datetimeFigureOut">
              <a:rPr lang="en-PH" smtClean="0"/>
              <a:t>24/01/2020</a:t>
            </a:fld>
            <a:endParaRPr lang="en-P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F87CA5-29BC-48A9-86AE-C053E02178A2}" type="slidenum">
              <a:rPr lang="en-PH" smtClean="0"/>
              <a:t>‹#›</a:t>
            </a:fld>
            <a:endParaRPr lang="en-PH"/>
          </a:p>
        </p:txBody>
      </p:sp>
    </p:spTree>
    <p:extLst>
      <p:ext uri="{BB962C8B-B14F-4D97-AF65-F5344CB8AC3E}">
        <p14:creationId xmlns:p14="http://schemas.microsoft.com/office/powerpoint/2010/main" val="10720208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PH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PH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PH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E9A9CD-DE84-4EEE-ABAB-E9C50D14D227}" type="datetimeFigureOut">
              <a:rPr lang="en-PH" smtClean="0"/>
              <a:t>24/01/2020</a:t>
            </a:fld>
            <a:endParaRPr lang="en-P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F87CA5-29BC-48A9-86AE-C053E02178A2}" type="slidenum">
              <a:rPr lang="en-PH" smtClean="0"/>
              <a:t>‹#›</a:t>
            </a:fld>
            <a:endParaRPr lang="en-PH"/>
          </a:p>
        </p:txBody>
      </p:sp>
    </p:spTree>
    <p:extLst>
      <p:ext uri="{BB962C8B-B14F-4D97-AF65-F5344CB8AC3E}">
        <p14:creationId xmlns:p14="http://schemas.microsoft.com/office/powerpoint/2010/main" val="9427048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PH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PH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PH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E9A9CD-DE84-4EEE-ABAB-E9C50D14D227}" type="datetimeFigureOut">
              <a:rPr lang="en-PH" smtClean="0"/>
              <a:t>24/01/2020</a:t>
            </a:fld>
            <a:endParaRPr lang="en-PH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H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F87CA5-29BC-48A9-86AE-C053E02178A2}" type="slidenum">
              <a:rPr lang="en-PH" smtClean="0"/>
              <a:t>‹#›</a:t>
            </a:fld>
            <a:endParaRPr lang="en-PH"/>
          </a:p>
        </p:txBody>
      </p:sp>
    </p:spTree>
    <p:extLst>
      <p:ext uri="{BB962C8B-B14F-4D97-AF65-F5344CB8AC3E}">
        <p14:creationId xmlns:p14="http://schemas.microsoft.com/office/powerpoint/2010/main" val="6514675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PH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E9A9CD-DE84-4EEE-ABAB-E9C50D14D227}" type="datetimeFigureOut">
              <a:rPr lang="en-PH" smtClean="0"/>
              <a:t>24/01/2020</a:t>
            </a:fld>
            <a:endParaRPr lang="en-PH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H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F87CA5-29BC-48A9-86AE-C053E02178A2}" type="slidenum">
              <a:rPr lang="en-PH" smtClean="0"/>
              <a:t>‹#›</a:t>
            </a:fld>
            <a:endParaRPr lang="en-PH"/>
          </a:p>
        </p:txBody>
      </p:sp>
    </p:spTree>
    <p:extLst>
      <p:ext uri="{BB962C8B-B14F-4D97-AF65-F5344CB8AC3E}">
        <p14:creationId xmlns:p14="http://schemas.microsoft.com/office/powerpoint/2010/main" val="36380937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E9A9CD-DE84-4EEE-ABAB-E9C50D14D227}" type="datetimeFigureOut">
              <a:rPr lang="en-PH" smtClean="0"/>
              <a:t>24/01/2020</a:t>
            </a:fld>
            <a:endParaRPr lang="en-PH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H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F87CA5-29BC-48A9-86AE-C053E02178A2}" type="slidenum">
              <a:rPr lang="en-PH" smtClean="0"/>
              <a:t>‹#›</a:t>
            </a:fld>
            <a:endParaRPr lang="en-PH"/>
          </a:p>
        </p:txBody>
      </p:sp>
    </p:spTree>
    <p:extLst>
      <p:ext uri="{BB962C8B-B14F-4D97-AF65-F5344CB8AC3E}">
        <p14:creationId xmlns:p14="http://schemas.microsoft.com/office/powerpoint/2010/main" val="34326503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PH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PH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E9A9CD-DE84-4EEE-ABAB-E9C50D14D227}" type="datetimeFigureOut">
              <a:rPr lang="en-PH" smtClean="0"/>
              <a:t>24/01/2020</a:t>
            </a:fld>
            <a:endParaRPr lang="en-P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F87CA5-29BC-48A9-86AE-C053E02178A2}" type="slidenum">
              <a:rPr lang="en-PH" smtClean="0"/>
              <a:t>‹#›</a:t>
            </a:fld>
            <a:endParaRPr lang="en-PH"/>
          </a:p>
        </p:txBody>
      </p:sp>
    </p:spTree>
    <p:extLst>
      <p:ext uri="{BB962C8B-B14F-4D97-AF65-F5344CB8AC3E}">
        <p14:creationId xmlns:p14="http://schemas.microsoft.com/office/powerpoint/2010/main" val="31677960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PH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PH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E9A9CD-DE84-4EEE-ABAB-E9C50D14D227}" type="datetimeFigureOut">
              <a:rPr lang="en-PH" smtClean="0"/>
              <a:t>24/01/2020</a:t>
            </a:fld>
            <a:endParaRPr lang="en-P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F87CA5-29BC-48A9-86AE-C053E02178A2}" type="slidenum">
              <a:rPr lang="en-PH" smtClean="0"/>
              <a:t>‹#›</a:t>
            </a:fld>
            <a:endParaRPr lang="en-PH"/>
          </a:p>
        </p:txBody>
      </p:sp>
    </p:spTree>
    <p:extLst>
      <p:ext uri="{BB962C8B-B14F-4D97-AF65-F5344CB8AC3E}">
        <p14:creationId xmlns:p14="http://schemas.microsoft.com/office/powerpoint/2010/main" val="38709876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PH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P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E9A9CD-DE84-4EEE-ABAB-E9C50D14D227}" type="datetimeFigureOut">
              <a:rPr lang="en-PH" smtClean="0"/>
              <a:t>24/01/2020</a:t>
            </a:fld>
            <a:endParaRPr lang="en-P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P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F87CA5-29BC-48A9-86AE-C053E02178A2}" type="slidenum">
              <a:rPr lang="en-PH" smtClean="0"/>
              <a:t>‹#›</a:t>
            </a:fld>
            <a:endParaRPr lang="en-PH"/>
          </a:p>
        </p:txBody>
      </p:sp>
    </p:spTree>
    <p:extLst>
      <p:ext uri="{BB962C8B-B14F-4D97-AF65-F5344CB8AC3E}">
        <p14:creationId xmlns:p14="http://schemas.microsoft.com/office/powerpoint/2010/main" val="41223033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6" name="表格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41889106"/>
              </p:ext>
            </p:extLst>
          </p:nvPr>
        </p:nvGraphicFramePr>
        <p:xfrm>
          <a:off x="1763688" y="264555"/>
          <a:ext cx="5216005" cy="528066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628089">
                  <a:extLst>
                    <a:ext uri="{9D8B030D-6E8A-4147-A177-3AD203B41FA5}">
                      <a16:colId xmlns:a16="http://schemas.microsoft.com/office/drawing/2014/main" xmlns="" val="539104837"/>
                    </a:ext>
                  </a:extLst>
                </a:gridCol>
                <a:gridCol w="3587916">
                  <a:extLst>
                    <a:ext uri="{9D8B030D-6E8A-4147-A177-3AD203B41FA5}">
                      <a16:colId xmlns:a16="http://schemas.microsoft.com/office/drawing/2014/main" xmlns="" val="270345283"/>
                    </a:ext>
                  </a:extLst>
                </a:gridCol>
              </a:tblGrid>
              <a:tr h="209726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me</a:t>
                      </a:r>
                      <a:endParaRPr lang="zh-CN" sz="11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600" marR="4460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just" defTabSz="685800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quence 5’-3</a:t>
                      </a:r>
                      <a:r>
                        <a:rPr lang="en-US" sz="1100" kern="1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’</a:t>
                      </a:r>
                    </a:p>
                  </a:txBody>
                  <a:tcPr marL="44600" marR="4460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857353693"/>
                  </a:ext>
                </a:extLst>
              </a:tr>
              <a:tr h="209726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-S</a:t>
                      </a:r>
                      <a:endParaRPr lang="zh-CN" sz="11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600" marR="4460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CTCGAGACGGTCGATAAATTCCAGT</a:t>
                      </a:r>
                      <a:endParaRPr lang="zh-CN" sz="11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600" marR="4460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01371756"/>
                  </a:ext>
                </a:extLst>
              </a:tr>
              <a:tr h="209726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-A</a:t>
                      </a:r>
                      <a:endParaRPr lang="zh-CN" sz="11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600" marR="4460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GGAATTCTGGGCAGTGTTCCAAGTTTT</a:t>
                      </a:r>
                      <a:endParaRPr lang="zh-CN" sz="11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600" marR="4460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51056167"/>
                  </a:ext>
                </a:extLst>
              </a:tr>
              <a:tr h="209726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R-S</a:t>
                      </a:r>
                      <a:endParaRPr lang="zh-CN" sz="11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600" marR="4460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GGGATCCGTTGTTTGTGACTGGGTGGC</a:t>
                      </a:r>
                      <a:endParaRPr lang="zh-CN" sz="11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600" marR="4460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274508345"/>
                  </a:ext>
                </a:extLst>
              </a:tr>
              <a:tr h="209726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R-A</a:t>
                      </a:r>
                      <a:endParaRPr lang="zh-CN" sz="11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600" marR="4460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AAGCTTGCGGGAAGGTTCAAGTGGAG</a:t>
                      </a:r>
                      <a:endParaRPr lang="zh-CN" sz="11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600" marR="4460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833186106"/>
                  </a:ext>
                </a:extLst>
              </a:tr>
              <a:tr h="209726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YG-F</a:t>
                      </a:r>
                      <a:endParaRPr lang="zh-CN" sz="11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600" marR="4460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TGTAGGAGGGCGTGGATATGTCCT</a:t>
                      </a:r>
                      <a:endParaRPr lang="zh-CN" sz="11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600" marR="4460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716957291"/>
                  </a:ext>
                </a:extLst>
              </a:tr>
              <a:tr h="209726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YG-R</a:t>
                      </a:r>
                      <a:endParaRPr lang="zh-CN" sz="11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600" marR="4460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ACCCGCGGTCGGCATCTACTCTATTC</a:t>
                      </a:r>
                      <a:endParaRPr lang="zh-CN" sz="11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600" marR="4460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64036478"/>
                  </a:ext>
                </a:extLst>
              </a:tr>
              <a:tr h="209726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SRED-P1</a:t>
                      </a:r>
                      <a:endParaRPr lang="zh-CN" sz="11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600" marR="4460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ACCCGGGATGGCCTCCTCCGAGAACGTCATC</a:t>
                      </a:r>
                      <a:endParaRPr lang="zh-CN" sz="11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600" marR="4460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010189662"/>
                  </a:ext>
                </a:extLst>
              </a:tr>
              <a:tr h="209726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SRED-P2</a:t>
                      </a:r>
                      <a:endParaRPr lang="zh-CN" sz="11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600" marR="4460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ATCTAGACAGGAACAGGTGGTGGCG</a:t>
                      </a:r>
                      <a:endParaRPr lang="zh-CN" sz="11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600" marR="4460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07549164"/>
                  </a:ext>
                </a:extLst>
              </a:tr>
              <a:tr h="209726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EO-</a:t>
                      </a:r>
                      <a:r>
                        <a:rPr lang="en-US" sz="1100" kern="1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l</a:t>
                      </a:r>
                      <a:endParaRPr lang="zh-CN" sz="11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600" marR="4460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CGATATCGAGGTCAACACATCAATGC</a:t>
                      </a:r>
                      <a:endParaRPr lang="zh-CN" sz="11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600" marR="4460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561761085"/>
                  </a:ext>
                </a:extLst>
              </a:tr>
              <a:tr h="91440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EO-p2</a:t>
                      </a:r>
                      <a:endParaRPr lang="zh-CN" sz="11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600" marR="4460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TCTGCAGTCAGAAGAACTCGTCAAGAAGGCG</a:t>
                      </a:r>
                      <a:endParaRPr lang="zh-CN" sz="11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600" marR="4460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459222462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altLang="zh-CN" sz="1100" b="1" kern="1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pZFC3-S</a:t>
                      </a:r>
                      <a:endParaRPr lang="zh-CN" sz="1100" b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600" marR="4460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altLang="zh-CN" sz="11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CCCGGG</a:t>
                      </a:r>
                      <a:r>
                        <a:rPr kumimoji="0" lang="en-US" altLang="zh-CN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TTAGTGCTTCTACGCGGTG</a:t>
                      </a:r>
                      <a:endParaRPr lang="zh-CN" sz="11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600" marR="4460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69304938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altLang="zh-CN" sz="1100" kern="1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pZFC3-A</a:t>
                      </a:r>
                      <a:endParaRPr lang="zh-CN" sz="11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600" marR="4460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just" defTabSz="685800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1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GGGTACC</a:t>
                      </a:r>
                      <a:r>
                        <a:rPr kumimoji="0" lang="en-US" altLang="zh-CN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TAACCAGCCTGTTCGTTGC</a:t>
                      </a:r>
                    </a:p>
                  </a:txBody>
                  <a:tcPr marL="44600" marR="4460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471024405"/>
                  </a:ext>
                </a:extLst>
              </a:tr>
              <a:tr h="209726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p6-1</a:t>
                      </a:r>
                      <a:endParaRPr lang="zh-CN" sz="11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600" marR="4460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TATTAGGATCAACAATCTTAGGA</a:t>
                      </a:r>
                      <a:endParaRPr lang="zh-CN" sz="11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600" marR="4460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525599654"/>
                  </a:ext>
                </a:extLst>
              </a:tr>
              <a:tr h="209726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p6-2</a:t>
                      </a:r>
                      <a:endParaRPr lang="zh-CN" sz="11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600" marR="4460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GCTAATCTTAACCCTAATGAGATA</a:t>
                      </a:r>
                      <a:endParaRPr lang="zh-CN" sz="11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600" marR="4460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376624800"/>
                  </a:ext>
                </a:extLst>
              </a:tr>
              <a:tr h="209726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p8-1</a:t>
                      </a:r>
                      <a:endParaRPr lang="zh-CN" sz="11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600" marR="4460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GCCTCAATTAGTTCCTTTTTA</a:t>
                      </a:r>
                      <a:endParaRPr lang="zh-CN" sz="11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600" marR="4460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671045390"/>
                  </a:ext>
                </a:extLst>
              </a:tr>
              <a:tr h="209726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p8-2</a:t>
                      </a:r>
                      <a:endParaRPr lang="zh-CN" sz="11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600" marR="4460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GAAAAGCTTAGATATTAATGTACG</a:t>
                      </a:r>
                      <a:endParaRPr lang="zh-CN" sz="11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600" marR="4460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611788007"/>
                  </a:ext>
                </a:extLst>
              </a:tr>
              <a:tr h="209726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p9-1</a:t>
                      </a:r>
                      <a:endParaRPr lang="zh-CN" sz="11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600" marR="4460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ATGGTCGAGGTCTCCAAGAA</a:t>
                      </a:r>
                      <a:endParaRPr lang="zh-CN" sz="11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600" marR="4460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923077633"/>
                  </a:ext>
                </a:extLst>
              </a:tr>
              <a:tr h="209726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p9-2</a:t>
                      </a:r>
                      <a:endParaRPr lang="zh-CN" sz="11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600" marR="4460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GAAACCCAGAATGGCGTA</a:t>
                      </a:r>
                      <a:endParaRPr lang="zh-CN" sz="11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600" marR="4460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263128251"/>
                  </a:ext>
                </a:extLst>
              </a:tr>
              <a:tr h="209726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tin-S</a:t>
                      </a:r>
                      <a:endParaRPr lang="zh-CN" sz="11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600" marR="4460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AGGAGTCTTAGGATTTGTGTTAAA</a:t>
                      </a:r>
                      <a:endParaRPr lang="zh-CN" sz="11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600" marR="4460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114702613"/>
                  </a:ext>
                </a:extLst>
              </a:tr>
              <a:tr h="209726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tin-A</a:t>
                      </a:r>
                      <a:endParaRPr lang="zh-CN" sz="11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600" marR="4460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TGTAAAAAGCAACTAGAATACCCA</a:t>
                      </a:r>
                      <a:endParaRPr lang="zh-CN" sz="11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600" marR="4460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5694400"/>
                  </a:ext>
                </a:extLst>
              </a:tr>
            </a:tbl>
          </a:graphicData>
        </a:graphic>
      </p:graphicFrame>
      <p:sp>
        <p:nvSpPr>
          <p:cNvPr id="27" name="矩形 2"/>
          <p:cNvSpPr/>
          <p:nvPr/>
        </p:nvSpPr>
        <p:spPr>
          <a:xfrm>
            <a:off x="107504" y="0"/>
            <a:ext cx="124585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ea typeface="宋体" panose="02010600030101010101" pitchFamily="2" charset="-122"/>
              </a:rPr>
              <a:t>Additional file </a:t>
            </a:r>
            <a:r>
              <a:rPr lang="en-US" altLang="zh-CN" sz="1200" b="1" dirty="0" smtClean="0">
                <a:latin typeface="Times New Roman" panose="02020603050405020304" pitchFamily="18" charset="0"/>
                <a:ea typeface="宋体" panose="02010600030101010101" pitchFamily="2" charset="-122"/>
              </a:rPr>
              <a:t>3</a:t>
            </a:r>
            <a:endParaRPr lang="zh-CN" altLang="en-US" sz="1200" dirty="0"/>
          </a:p>
        </p:txBody>
      </p:sp>
    </p:spTree>
    <p:extLst>
      <p:ext uri="{BB962C8B-B14F-4D97-AF65-F5344CB8AC3E}">
        <p14:creationId xmlns:p14="http://schemas.microsoft.com/office/powerpoint/2010/main" val="27711193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49</Words>
  <Application>Microsoft Office PowerPoint</Application>
  <PresentationFormat>On-screen Show (4:3)</PresentationFormat>
  <Paragraphs>4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FRENACIA</dc:creator>
  <cp:lastModifiedBy>AFRENACIA</cp:lastModifiedBy>
  <cp:revision>3</cp:revision>
  <dcterms:created xsi:type="dcterms:W3CDTF">2020-01-24T06:10:12Z</dcterms:created>
  <dcterms:modified xsi:type="dcterms:W3CDTF">2020-01-24T06:12:02Z</dcterms:modified>
</cp:coreProperties>
</file>